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56" d="100"/>
          <a:sy n="56" d="100"/>
        </p:scale>
        <p:origin x="108" y="12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F7F7CA-ADBB-4273-BD1B-94CF761E84B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F60C6D6-4AD9-44BE-ACB3-17DEB23E170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E24B5C-B6FA-4776-8C74-FED8058933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F9451-7C3F-4E6A-9982-7FFC995FB795}" type="datetimeFigureOut">
              <a:rPr lang="en-CA" smtClean="0"/>
              <a:t>2020-12-12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204F90-8612-431D-B0A9-187A2AF5B5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BD5DD4-3362-4CDA-A998-AE958C67A0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6BE27D-882E-4BC7-AE6E-EAB44F2FBA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08192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9F0012-7EDE-4C9B-A380-9CCE247F60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4D94E0F-FB50-47FF-B7BD-3EC699E436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144129-F1F1-49D6-BD4B-89142C4C10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F9451-7C3F-4E6A-9982-7FFC995FB795}" type="datetimeFigureOut">
              <a:rPr lang="en-CA" smtClean="0"/>
              <a:t>2020-12-12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46F434-0B0B-4746-9B53-AD7033863D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DB9A8C-7ABE-4F5F-A2F6-061E7A3E2F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6BE27D-882E-4BC7-AE6E-EAB44F2FBA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835394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AA4BE33-3CDC-43D6-A617-A00B4F43CB5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54CB090-EA7A-45D2-999F-ADE679FC036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65E2C6-28DF-4A9D-B8AA-62A0A8481F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F9451-7C3F-4E6A-9982-7FFC995FB795}" type="datetimeFigureOut">
              <a:rPr lang="en-CA" smtClean="0"/>
              <a:t>2020-12-12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588D52-AA64-4DD4-A3E4-C2C6B303A8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11A78A-50FF-4949-BE28-BD4206F1F1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6BE27D-882E-4BC7-AE6E-EAB44F2FBA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822512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BE3188-A8F1-4F1F-8EE5-D829882A50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84CC2C-203D-42BF-87D0-BE3F7D4B7DF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53ED8A-3388-4890-A51D-0AF58CEF99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F9451-7C3F-4E6A-9982-7FFC995FB795}" type="datetimeFigureOut">
              <a:rPr lang="en-CA" smtClean="0"/>
              <a:t>2020-12-12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F2C7A4-DBA7-4873-94E0-F0C11B50DB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C5D906-E3CA-4895-AF50-AC5AE3CABC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6BE27D-882E-4BC7-AE6E-EAB44F2FBA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370851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19576E-32B3-490A-8AF4-A41D164823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82C59A-DFC9-4A49-9319-54CC9A392B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086446-9034-428C-9FA8-DBC6D9971A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F9451-7C3F-4E6A-9982-7FFC995FB795}" type="datetimeFigureOut">
              <a:rPr lang="en-CA" smtClean="0"/>
              <a:t>2020-12-12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6DA90A-63AA-4A7F-B5B2-DE78345493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DE4686-3C30-424E-8E34-7776FE8F75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6BE27D-882E-4BC7-AE6E-EAB44F2FBA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803705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90CAC2-743C-45BC-9B2D-35A9C97185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3199DD-56CC-4A96-B0D7-2737C27D1F7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717344E-4FBC-4D51-8B1B-29CEFC12A1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49F0E11-7B0E-4404-A442-E26DD54FB9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F9451-7C3F-4E6A-9982-7FFC995FB795}" type="datetimeFigureOut">
              <a:rPr lang="en-CA" smtClean="0"/>
              <a:t>2020-12-12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01547A-0509-4548-906A-48AA9ECD81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3025658-F58A-4FB7-A7B3-8F2A4F65CB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6BE27D-882E-4BC7-AE6E-EAB44F2FBA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06206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E92E7F-44E8-45DE-B48E-48403B3F82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E9CAE2-E4F6-4146-882C-F32657BD9E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690F241-2969-46B8-8A19-511BC3AB7E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6DA1823-58BA-4F1B-8038-E8D9A853EEB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242C13F-8194-48FD-A376-C1E02C4F7CA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19D565C-BC74-46A7-B024-07F030C4DE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F9451-7C3F-4E6A-9982-7FFC995FB795}" type="datetimeFigureOut">
              <a:rPr lang="en-CA" smtClean="0"/>
              <a:t>2020-12-12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154B31A-5FBD-4C32-8917-F5EEA433E0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DFA86BB-148B-43CA-A342-35F1180D95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6BE27D-882E-4BC7-AE6E-EAB44F2FBA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741624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5432E3-E9FF-45A8-B926-5686417423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928F545-26D5-4ACD-866E-CD1E7C0B97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F9451-7C3F-4E6A-9982-7FFC995FB795}" type="datetimeFigureOut">
              <a:rPr lang="en-CA" smtClean="0"/>
              <a:t>2020-12-12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DF2A712-B514-44CF-A74C-81E451F7D6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0A57B99-B711-4724-A660-5999F67E72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6BE27D-882E-4BC7-AE6E-EAB44F2FBA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305510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5206A4D-76A3-4B2B-B908-4EDFA8B87B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F9451-7C3F-4E6A-9982-7FFC995FB795}" type="datetimeFigureOut">
              <a:rPr lang="en-CA" smtClean="0"/>
              <a:t>2020-12-12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AC873AA-F85B-4675-B7BD-4E2B41121F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2B8199C-BCC1-4169-B396-6ED695AA97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6BE27D-882E-4BC7-AE6E-EAB44F2FBA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53455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B8C7A8-8330-494C-98C1-890725EA6E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405B3B-70CF-4115-B97E-8280244E143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9E5106F-002F-435F-8639-CC6EB46987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3F6FE2-1289-41AD-8869-E4841CB913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F9451-7C3F-4E6A-9982-7FFC995FB795}" type="datetimeFigureOut">
              <a:rPr lang="en-CA" smtClean="0"/>
              <a:t>2020-12-12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C6A7639-B1E3-4165-AC12-7C087F2FE7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BEE081D-A9B2-4A3D-9E9F-24648367A2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6BE27D-882E-4BC7-AE6E-EAB44F2FBA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797577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DCFD4B-4286-4E16-9FE7-0D02F2CA14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D8234FA-CA9A-46E1-A96B-4535BD078EB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559FFE2-8D77-4DD8-9DD0-A6AA109D06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4746B5-6446-411D-A12F-7D3930A65E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F9451-7C3F-4E6A-9982-7FFC995FB795}" type="datetimeFigureOut">
              <a:rPr lang="en-CA" smtClean="0"/>
              <a:t>2020-12-12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1BFAB9-53A8-437B-92AE-F5DCACE45D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FC55D8-6556-457E-A837-C3D5842F92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6BE27D-882E-4BC7-AE6E-EAB44F2FBA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816966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F0DEE63-960B-428E-8A22-0181A479FE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7599DB-7679-43D5-97E1-70CB64A666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D2C32D-78E8-4927-8C2C-5C7C6AF2B83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AF9451-7C3F-4E6A-9982-7FFC995FB795}" type="datetimeFigureOut">
              <a:rPr lang="en-CA" smtClean="0"/>
              <a:t>2020-12-12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0F1AE8-75C4-4207-BE26-B66FE247120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01351B-5F3B-4FB8-973E-98704A7F088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6BE27D-882E-4BC7-AE6E-EAB44F2FBA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377428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84D46B39-DFF3-4A71-9DF9-D44D71D41C2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18654" y="1814513"/>
            <a:ext cx="2613345" cy="3228974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F39530F8-4D68-4E5F-8547-34029903634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31999" y="1962912"/>
            <a:ext cx="2581656" cy="2932176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BA9CA29E-5C69-4AC2-ADC3-F15C9DE1F7C9}"/>
              </a:ext>
            </a:extLst>
          </p:cNvPr>
          <p:cNvSpPr txBox="1"/>
          <p:nvPr/>
        </p:nvSpPr>
        <p:spPr>
          <a:xfrm>
            <a:off x="2218655" y="4895088"/>
            <a:ext cx="5195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gure 1: Swelling (%) and mass loss (%) of various PCL/nHA compositions after 21 days of immersion in PBS.. No significant difference in swelling or mass loss was found; however, an increasing trend in swelling with increased nHA addition can be seen.</a:t>
            </a:r>
          </a:p>
        </p:txBody>
      </p:sp>
    </p:spTree>
    <p:extLst>
      <p:ext uri="{BB962C8B-B14F-4D97-AF65-F5344CB8AC3E}">
        <p14:creationId xmlns:p14="http://schemas.microsoft.com/office/powerpoint/2010/main" val="14327453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5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anda</dc:creator>
  <cp:lastModifiedBy>Amanda</cp:lastModifiedBy>
  <cp:revision>3</cp:revision>
  <dcterms:created xsi:type="dcterms:W3CDTF">2020-12-12T21:19:42Z</dcterms:created>
  <dcterms:modified xsi:type="dcterms:W3CDTF">2020-12-12T21:33:38Z</dcterms:modified>
</cp:coreProperties>
</file>